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1" autoAdjust="0"/>
    <p:restoredTop sz="94660"/>
  </p:normalViewPr>
  <p:slideViewPr>
    <p:cSldViewPr snapToGrid="0">
      <p:cViewPr varScale="1">
        <p:scale>
          <a:sx n="67" d="100"/>
          <a:sy n="67" d="100"/>
        </p:scale>
        <p:origin x="5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456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1639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06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8376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6392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1013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23508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235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6491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6877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25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341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20107"/>
          <a:stretch/>
        </p:blipFill>
        <p:spPr>
          <a:xfrm>
            <a:off x="3152380" y="873759"/>
            <a:ext cx="5805960" cy="569976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48080" y="689093"/>
            <a:ext cx="105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Supplemental Figure 1: NGS data showing mutation in 3 affected members of the family carrying APC mutation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361040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ti Khanna Gupta</dc:creator>
  <cp:lastModifiedBy>Arati Khanna Gupta</cp:lastModifiedBy>
  <cp:revision>1</cp:revision>
  <dcterms:created xsi:type="dcterms:W3CDTF">2018-05-24T17:28:18Z</dcterms:created>
  <dcterms:modified xsi:type="dcterms:W3CDTF">2018-05-24T17:29:04Z</dcterms:modified>
</cp:coreProperties>
</file>